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3" autoAdjust="0"/>
    <p:restoredTop sz="94660"/>
  </p:normalViewPr>
  <p:slideViewPr>
    <p:cSldViewPr snapToGrid="0">
      <p:cViewPr>
        <p:scale>
          <a:sx n="80" d="100"/>
          <a:sy n="80" d="100"/>
        </p:scale>
        <p:origin x="1422" y="-21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5BDF5F-9869-4B9F-B498-CDB61F5BD8BC}" type="datetimeFigureOut">
              <a:rPr lang="en-US" smtClean="0"/>
              <a:t>1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0AFBE-FCC1-41C2-9C9A-C1FFF9CE3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08593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5BDF5F-9869-4B9F-B498-CDB61F5BD8BC}" type="datetimeFigureOut">
              <a:rPr lang="en-US" smtClean="0"/>
              <a:t>1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0AFBE-FCC1-41C2-9C9A-C1FFF9CE3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86387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5BDF5F-9869-4B9F-B498-CDB61F5BD8BC}" type="datetimeFigureOut">
              <a:rPr lang="en-US" smtClean="0"/>
              <a:t>1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0AFBE-FCC1-41C2-9C9A-C1FFF9CE3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83343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5BDF5F-9869-4B9F-B498-CDB61F5BD8BC}" type="datetimeFigureOut">
              <a:rPr lang="en-US" smtClean="0"/>
              <a:t>1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0AFBE-FCC1-41C2-9C9A-C1FFF9CE3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06648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5BDF5F-9869-4B9F-B498-CDB61F5BD8BC}" type="datetimeFigureOut">
              <a:rPr lang="en-US" smtClean="0"/>
              <a:t>1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0AFBE-FCC1-41C2-9C9A-C1FFF9CE3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57585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5BDF5F-9869-4B9F-B498-CDB61F5BD8BC}" type="datetimeFigureOut">
              <a:rPr lang="en-US" smtClean="0"/>
              <a:t>1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0AFBE-FCC1-41C2-9C9A-C1FFF9CE3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74412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5BDF5F-9869-4B9F-B498-CDB61F5BD8BC}" type="datetimeFigureOut">
              <a:rPr lang="en-US" smtClean="0"/>
              <a:t>1/2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0AFBE-FCC1-41C2-9C9A-C1FFF9CE3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59488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5BDF5F-9869-4B9F-B498-CDB61F5BD8BC}" type="datetimeFigureOut">
              <a:rPr lang="en-US" smtClean="0"/>
              <a:t>1/2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0AFBE-FCC1-41C2-9C9A-C1FFF9CE3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8066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5BDF5F-9869-4B9F-B498-CDB61F5BD8BC}" type="datetimeFigureOut">
              <a:rPr lang="en-US" smtClean="0"/>
              <a:t>1/2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0AFBE-FCC1-41C2-9C9A-C1FFF9CE3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58122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5BDF5F-9869-4B9F-B498-CDB61F5BD8BC}" type="datetimeFigureOut">
              <a:rPr lang="en-US" smtClean="0"/>
              <a:t>1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0AFBE-FCC1-41C2-9C9A-C1FFF9CE3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09535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5BDF5F-9869-4B9F-B498-CDB61F5BD8BC}" type="datetimeFigureOut">
              <a:rPr lang="en-US" smtClean="0"/>
              <a:t>1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0AFBE-FCC1-41C2-9C9A-C1FFF9CE3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68522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5BDF5F-9869-4B9F-B498-CDB61F5BD8BC}" type="datetimeFigureOut">
              <a:rPr lang="en-US" smtClean="0"/>
              <a:t>1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10AFBE-FCC1-41C2-9C9A-C1FFF9CE3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3735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4F6E57F3-21C0-49A8-A480-3DA518499C1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721" b="13103"/>
          <a:stretch/>
        </p:blipFill>
        <p:spPr>
          <a:xfrm>
            <a:off x="-1" y="718458"/>
            <a:ext cx="6930551" cy="7075713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257FD353-E5C5-402D-B810-DF63DEB1451A}"/>
              </a:ext>
            </a:extLst>
          </p:cNvPr>
          <p:cNvSpPr txBox="1"/>
          <p:nvPr/>
        </p:nvSpPr>
        <p:spPr>
          <a:xfrm>
            <a:off x="560903" y="7529467"/>
            <a:ext cx="597224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aphical genotypes of the reciprocal CSSLs. (a) 41 K-CSSLs, (b) 39 T-CSSLs. Orange regions indicate homozygosity for Koshihikari; blue regions indicate homozygosity for Takanari. Gray region indicates heterozygosity. Genotypes of the 141 SSR markers in both CSSLs are shown in the upper parts of graphs. a: Koshihikari genotype, b: Takanari genotype.</a:t>
            </a:r>
          </a:p>
        </p:txBody>
      </p:sp>
    </p:spTree>
    <p:extLst>
      <p:ext uri="{BB962C8B-B14F-4D97-AF65-F5344CB8AC3E}">
        <p14:creationId xmlns:p14="http://schemas.microsoft.com/office/powerpoint/2010/main" val="12395615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68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ndria Mulsanti</dc:creator>
  <cp:lastModifiedBy>Indria Mulsanti</cp:lastModifiedBy>
  <cp:revision>1</cp:revision>
  <dcterms:created xsi:type="dcterms:W3CDTF">2018-01-26T09:04:00Z</dcterms:created>
  <dcterms:modified xsi:type="dcterms:W3CDTF">2018-01-26T09:08:15Z</dcterms:modified>
</cp:coreProperties>
</file>